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-90" y="-16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6D5DFB3F-2744-4367-BBC2-833894504C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10A0FF6F-DAE4-43D7-978A-A5DEE62276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71136242-2F26-4340-A5A4-5D8E69126B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21E59-EA67-4CDE-9590-13611DC84D81}" type="datetimeFigureOut">
              <a:rPr lang="zh-CN" altLang="en-US" smtClean="0"/>
              <a:pPr/>
              <a:t>2020/7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50DD4504-67CF-4C5F-9864-731E48FA23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F3C7B5EA-9A3F-41B6-9B0C-C2DBBB003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4741C-6916-4029-8614-53980F9046D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1469169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6FFF898-A7B9-4483-AB0E-7CB19E88A6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FD8F6AC9-FF62-4847-85A4-ACDEBAAC38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5F3EEC4A-9CA8-49D2-94AE-868E8CA5F0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21E59-EA67-4CDE-9590-13611DC84D81}" type="datetimeFigureOut">
              <a:rPr lang="zh-CN" altLang="en-US" smtClean="0"/>
              <a:pPr/>
              <a:t>2020/7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B4F91693-3329-4DFD-A950-67BAE8B3F0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BEB163B1-2E8D-4B9A-AB3B-4AE4F3BA93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4741C-6916-4029-8614-53980F9046D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2587975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0948E7C7-1F91-4E90-A38B-35867677320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A18BCBD6-4987-4A6E-985C-13FD55C59D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CE10EBD-CC42-4CEE-92A8-A343078544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21E59-EA67-4CDE-9590-13611DC84D81}" type="datetimeFigureOut">
              <a:rPr lang="zh-CN" altLang="en-US" smtClean="0"/>
              <a:pPr/>
              <a:t>2020/7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A5AC7F95-BBF5-402E-AC85-5F93189C2D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DDDA2FE6-3D91-48F6-BE8D-10479CA459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4741C-6916-4029-8614-53980F9046D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9130584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C942CB20-1703-4902-AAE5-4904EF949B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877BB90E-089C-4EEA-8018-1C752DF835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B578AE9B-339A-4A63-8CA4-69A4BB470B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21E59-EA67-4CDE-9590-13611DC84D81}" type="datetimeFigureOut">
              <a:rPr lang="zh-CN" altLang="en-US" smtClean="0"/>
              <a:pPr/>
              <a:t>2020/7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098D9B76-6681-422C-9380-58F8BEEB98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C9EFDEB8-5390-419C-BB21-7976664570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4741C-6916-4029-8614-53980F9046D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3699573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202F484E-3562-4215-A0A0-609AFE5997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80C6A99F-1BAB-4B6D-924A-2CED2C9057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988CB13B-742F-426D-B1C1-B2E218FEF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21E59-EA67-4CDE-9590-13611DC84D81}" type="datetimeFigureOut">
              <a:rPr lang="zh-CN" altLang="en-US" smtClean="0"/>
              <a:pPr/>
              <a:t>2020/7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2BF657AE-C30D-4CE1-A328-4E06681FF8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C86D859B-9586-4C75-B717-A4BB7B2333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4741C-6916-4029-8614-53980F9046D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6624789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124D18BF-4E19-4D4B-A0AE-C8E74E3F91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CA492467-5877-4812-9EBF-261EB38B5CA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72646653-AD54-4ED8-8784-4A088A50B7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44FA5875-35D7-48EF-ADB9-CB41C28DA0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21E59-EA67-4CDE-9590-13611DC84D81}" type="datetimeFigureOut">
              <a:rPr lang="zh-CN" altLang="en-US" smtClean="0"/>
              <a:pPr/>
              <a:t>2020/7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5A81F817-2D91-488B-A698-89F62CD9DF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35592901-D0A6-4660-B5AE-50239BD92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4741C-6916-4029-8614-53980F9046D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870377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8A15A45-FDF3-41D6-AA0D-53BD485641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6CA4CEF3-C569-4685-88EA-93FF16EF00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037DC563-8B69-4D7F-800C-88F376ED17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44D31D30-F857-4487-93C8-4314F82F2CF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EB56869D-131E-4BFB-95F6-E69FC9BD0B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C67F6576-F374-474C-975B-0A2948A055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21E59-EA67-4CDE-9590-13611DC84D81}" type="datetimeFigureOut">
              <a:rPr lang="zh-CN" altLang="en-US" smtClean="0"/>
              <a:pPr/>
              <a:t>2020/7/2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237D39E6-9C6A-4F73-9515-7DC2B8DB9C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8C5A63EA-9C49-4A57-B5CB-50553F63EF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4741C-6916-4029-8614-53980F9046D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249583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AC624B14-C922-4F3C-81CB-D370366F2F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18C88CFC-D25C-47B0-A6E1-94C80CC990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21E59-EA67-4CDE-9590-13611DC84D81}" type="datetimeFigureOut">
              <a:rPr lang="zh-CN" altLang="en-US" smtClean="0"/>
              <a:pPr/>
              <a:t>2020/7/2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1F1F745F-43AC-42E8-92F5-C44FE3E984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DBF737D2-A152-4F63-951B-1CF957DB60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4741C-6916-4029-8614-53980F9046D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8422685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095C331C-8BE8-4EAE-8289-18B53A83F6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21E59-EA67-4CDE-9590-13611DC84D81}" type="datetimeFigureOut">
              <a:rPr lang="zh-CN" altLang="en-US" smtClean="0"/>
              <a:pPr/>
              <a:t>2020/7/2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6A3B3144-6706-431F-8197-B83215923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094AA6DC-EA68-4BA0-9FFC-6867949C7D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4741C-6916-4029-8614-53980F9046D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182406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B1313EEF-E4AE-4E18-812E-29A610C272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D4645BF8-0B5D-4638-9853-AAE3CEEFE0B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5B774932-AB22-4372-835E-2BCDFA796A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2CA08E10-10DE-4177-9FE7-F50FE5690A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21E59-EA67-4CDE-9590-13611DC84D81}" type="datetimeFigureOut">
              <a:rPr lang="zh-CN" altLang="en-US" smtClean="0"/>
              <a:pPr/>
              <a:t>2020/7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72A5646D-FAEB-4B0D-9CA0-B5B1193003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7B20E8DD-6CEA-432A-AA7A-31BC2E2AEE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4741C-6916-4029-8614-53980F9046D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1436030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45F3459D-498B-4F06-BE53-9D7E1037E2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AB647F6C-258B-4C92-A650-FF80607DC3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2D6CC35A-4390-4CC6-A627-2E80A22459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9DBE5FCA-D60B-475D-AA56-4D6CFABDAF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21E59-EA67-4CDE-9590-13611DC84D81}" type="datetimeFigureOut">
              <a:rPr lang="zh-CN" altLang="en-US" smtClean="0"/>
              <a:pPr/>
              <a:t>2020/7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EB4112C9-2495-4E56-B77E-D674FA9A85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76080941-434F-4EAC-A954-3E3F70F8D1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4741C-6916-4029-8614-53980F9046D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1938896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F756239A-A7A3-4E59-84EF-5CB0271B00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6A3A6A0E-5F24-4B88-912A-53A256523C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B821E8A6-685F-4255-B8E7-668A065F27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021E59-EA67-4CDE-9590-13611DC84D81}" type="datetimeFigureOut">
              <a:rPr lang="zh-CN" altLang="en-US" smtClean="0"/>
              <a:pPr/>
              <a:t>2020/7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1E27082F-7055-47C9-BDB6-64F4E23E792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51F9BAE1-455F-4809-A39A-C233A729AB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34741C-6916-4029-8614-53980F9046D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233881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>
            <a:extLst>
              <a:ext uri="{FF2B5EF4-FFF2-40B4-BE49-F238E27FC236}">
                <a16:creationId xmlns:a16="http://schemas.microsoft.com/office/drawing/2014/main" xmlns="" id="{20791416-8F6A-4914-920B-FD8B1116383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6807" r="7331"/>
          <a:stretch/>
        </p:blipFill>
        <p:spPr>
          <a:xfrm>
            <a:off x="790126" y="1377349"/>
            <a:ext cx="4891584" cy="3574875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xmlns="" id="{AD2A925F-9937-4688-ABD1-22DBD8A746A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r="8418"/>
          <a:stretch/>
        </p:blipFill>
        <p:spPr>
          <a:xfrm>
            <a:off x="6936718" y="1386733"/>
            <a:ext cx="5135355" cy="3353943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xmlns="" id="{E1979370-96C5-4877-82A6-9C95450519CD}"/>
              </a:ext>
            </a:extLst>
          </p:cNvPr>
          <p:cNvSpPr/>
          <p:nvPr/>
        </p:nvSpPr>
        <p:spPr>
          <a:xfrm>
            <a:off x="0" y="0"/>
            <a:ext cx="139012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endParaRPr lang="zh-CN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xmlns="" id="{C51ECBB4-A3A2-46F7-9513-59485A08C1E7}"/>
              </a:ext>
            </a:extLst>
          </p:cNvPr>
          <p:cNvSpPr/>
          <p:nvPr/>
        </p:nvSpPr>
        <p:spPr>
          <a:xfrm>
            <a:off x="935112" y="5632702"/>
            <a:ext cx="1065912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smtClean="0">
                <a:latin typeface="Times New Roman" panose="02020603050405020304" pitchFamily="18" charset="0"/>
              </a:rPr>
              <a:t>Figure </a:t>
            </a:r>
            <a:r>
              <a:rPr lang="en-US" altLang="zh-CN" b="1" dirty="0">
                <a:latin typeface="Times New Roman" panose="02020603050405020304" pitchFamily="18" charset="0"/>
              </a:rPr>
              <a:t>S1: </a:t>
            </a:r>
            <a:r>
              <a:rPr lang="en-US" altLang="zh-CN" dirty="0">
                <a:latin typeface="Times New Roman" panose="02020603050405020304" pitchFamily="18" charset="0"/>
              </a:rPr>
              <a:t>KM survival curves for overall survival in normal and overall KIRC patients by ICGC (a) and UCSC </a:t>
            </a:r>
            <a:r>
              <a:rPr lang="en-US" altLang="zh-CN" dirty="0" err="1">
                <a:latin typeface="Times New Roman" panose="02020603050405020304" pitchFamily="18" charset="0"/>
              </a:rPr>
              <a:t>Xena</a:t>
            </a:r>
            <a:r>
              <a:rPr lang="en-US" altLang="zh-CN" dirty="0">
                <a:latin typeface="Times New Roman" panose="02020603050405020304" pitchFamily="18" charset="0"/>
              </a:rPr>
              <a:t> database (b).</a:t>
            </a:r>
            <a:endParaRPr lang="zh-CN" altLang="en-US" dirty="0"/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xmlns="" id="{5D35F7CA-2720-48D0-8732-3A79810A693A}"/>
              </a:ext>
            </a:extLst>
          </p:cNvPr>
          <p:cNvSpPr/>
          <p:nvPr/>
        </p:nvSpPr>
        <p:spPr>
          <a:xfrm>
            <a:off x="392912" y="1225298"/>
            <a:ext cx="364202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xmlns="" id="{83EF3319-CF5B-47CD-80C9-9B2F9BDA3A05}"/>
              </a:ext>
            </a:extLst>
          </p:cNvPr>
          <p:cNvSpPr/>
          <p:nvPr/>
        </p:nvSpPr>
        <p:spPr>
          <a:xfrm>
            <a:off x="6510292" y="1225298"/>
            <a:ext cx="385042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0864658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4</TotalTime>
  <Words>31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桃桃 梁</dc:creator>
  <cp:lastModifiedBy>0013358</cp:lastModifiedBy>
  <cp:revision>5</cp:revision>
  <dcterms:created xsi:type="dcterms:W3CDTF">2020-07-09T01:42:49Z</dcterms:created>
  <dcterms:modified xsi:type="dcterms:W3CDTF">2020-07-23T14:52:31Z</dcterms:modified>
</cp:coreProperties>
</file>